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34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166CC6-5ED9-4C6F-BFB9-8099A4A45B0E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385CBD-B5F9-40DF-82BD-9CE04B1CD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376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D783E5-C4FD-4368-AA52-5A218A2CC376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9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8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68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688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01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148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03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0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5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544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80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29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>
            <a:off x="-41940" y="-6453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igure S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" name="Picture 13" descr="oxa-23 southern-2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14349" y="836712"/>
            <a:ext cx="3760784" cy="3240000"/>
          </a:xfrm>
          <a:prstGeom prst="rect">
            <a:avLst/>
          </a:prstGeom>
        </p:spPr>
      </p:pic>
      <p:pic>
        <p:nvPicPr>
          <p:cNvPr id="15" name="Picture 14" descr="virD4 southern-2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902400" y="836712"/>
            <a:ext cx="3384376" cy="3240000"/>
          </a:xfrm>
          <a:prstGeom prst="rect">
            <a:avLst/>
          </a:prstGeom>
        </p:spPr>
      </p:pic>
      <p:sp>
        <p:nvSpPr>
          <p:cNvPr id="17" name="Rectangle 1"/>
          <p:cNvSpPr>
            <a:spLocks noChangeArrowheads="1"/>
          </p:cNvSpPr>
          <p:nvPr/>
        </p:nvSpPr>
        <p:spPr bwMode="auto">
          <a:xfrm>
            <a:off x="5000628" y="476672"/>
            <a:ext cx="342902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indent="3810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                                                         </a:t>
            </a:r>
            <a:r>
              <a:rPr lang="en-US" sz="800" u="sng" dirty="0" err="1" smtClean="0">
                <a:latin typeface="Calibri" pitchFamily="34" charset="0"/>
                <a:ea typeface="华文中宋"/>
                <a:cs typeface="Times New Roman" pitchFamily="18" charset="0"/>
              </a:rPr>
              <a:t>chromosmal</a:t>
            </a:r>
            <a:r>
              <a:rPr lang="en-US" sz="800" u="sng" dirty="0" smtClean="0">
                <a:latin typeface="Calibri" pitchFamily="34" charset="0"/>
                <a:ea typeface="华文中宋"/>
                <a:cs typeface="Times New Roman" pitchFamily="18" charset="0"/>
              </a:rPr>
              <a:t> DNA</a:t>
            </a:r>
            <a:r>
              <a:rPr lang="en-US" sz="800" dirty="0" smtClean="0">
                <a:latin typeface="Calibri" pitchFamily="34" charset="0"/>
                <a:ea typeface="华文中宋"/>
                <a:cs typeface="Times New Roman" pitchFamily="18" charset="0"/>
              </a:rPr>
              <a:t>             </a:t>
            </a:r>
            <a:r>
              <a:rPr lang="en-US" sz="800" u="sng" dirty="0" smtClean="0">
                <a:latin typeface="Calibri" pitchFamily="34" charset="0"/>
                <a:ea typeface="华文中宋"/>
                <a:cs typeface="Times New Roman" pitchFamily="18" charset="0"/>
              </a:rPr>
              <a:t>plasmid DNA </a:t>
            </a:r>
          </a:p>
          <a:p>
            <a:pPr lvl="0" indent="3810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                  M      OXA-23    virD4      7104       868  blank      7104       868      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Rectangle 1"/>
          <p:cNvSpPr>
            <a:spLocks noChangeArrowheads="1"/>
          </p:cNvSpPr>
          <p:nvPr/>
        </p:nvSpPr>
        <p:spPr bwMode="auto">
          <a:xfrm>
            <a:off x="1157984" y="476672"/>
            <a:ext cx="424847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3810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                                                           </a:t>
            </a:r>
            <a:r>
              <a:rPr kumimoji="0" lang="en-US" sz="800" b="0" i="0" u="sng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chromosmal</a:t>
            </a:r>
            <a:r>
              <a:rPr kumimoji="0" lang="en-US" sz="8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 DNA</a:t>
            </a:r>
            <a:r>
              <a:rPr lang="en-US" sz="800" dirty="0" smtClean="0">
                <a:latin typeface="Calibri" pitchFamily="34" charset="0"/>
                <a:ea typeface="华文中宋"/>
                <a:cs typeface="Times New Roman" pitchFamily="18" charset="0"/>
              </a:rPr>
              <a:t>                     </a:t>
            </a:r>
            <a:r>
              <a:rPr kumimoji="0" lang="en-US" sz="8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plasmid DNA</a:t>
            </a:r>
            <a:endParaRPr lang="en-US" sz="800" u="sng" dirty="0" smtClean="0">
              <a:latin typeface="Calibri" pitchFamily="34" charset="0"/>
              <a:ea typeface="华文中宋"/>
              <a:cs typeface="Times New Roman" pitchFamily="18" charset="0"/>
            </a:endParaRPr>
          </a:p>
          <a:p>
            <a:pPr marL="0" marR="0" lvl="0" indent="3810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              </a:t>
            </a: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华文中宋"/>
                <a:cs typeface="Times New Roman" pitchFamily="18" charset="0"/>
              </a:rPr>
              <a:t>M    OXA-23        virD4         7104         868          blank      7104     868      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958184" y="400506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929454" y="40598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/>
        </p:nvGraphicFramePr>
        <p:xfrm>
          <a:off x="285721" y="4643446"/>
          <a:ext cx="8643997" cy="2025650"/>
        </p:xfrm>
        <a:graphic>
          <a:graphicData uri="http://schemas.openxmlformats.org/drawingml/2006/table">
            <a:tbl>
              <a:tblPr/>
              <a:tblGrid>
                <a:gridCol w="848578"/>
                <a:gridCol w="848578"/>
                <a:gridCol w="1682775"/>
                <a:gridCol w="2335108"/>
                <a:gridCol w="2928958"/>
              </a:tblGrid>
              <a:tr h="202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rob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rge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rai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outhern blo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pported genome organiza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56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XA-2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romosomal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DN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71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two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s (11337, 7943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Tn6206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d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r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are integrated in chromosome with alternative ord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56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8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two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s (11336, 7943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0256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lasmid DN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71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two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s 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7943,7245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two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types of free plasmid: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n6206+tra (band of 7943),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nd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Tn6206-only (band of 7245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56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8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two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s 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7943,7245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02565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56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irD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hromosomal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DN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71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one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 (1418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tra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locus in chromosom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56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8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one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 (1418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0256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lasmid DN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71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one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 (1418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1100" b="0" i="0" u="none" strike="noStrike" baseline="0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t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latin typeface="Times New Roman"/>
                        </a:rPr>
                        <a:t>ra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locus in free plasmi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56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JAB08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 one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band (1418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66963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53</Words>
  <Application>Microsoft Office PowerPoint</Application>
  <PresentationFormat>On-screen Show (4:3)</PresentationFormat>
  <Paragraphs>4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an Li</dc:creator>
  <cp:lastModifiedBy>Quan Li</cp:lastModifiedBy>
  <cp:revision>4</cp:revision>
  <dcterms:created xsi:type="dcterms:W3CDTF">2013-05-15T20:10:55Z</dcterms:created>
  <dcterms:modified xsi:type="dcterms:W3CDTF">2013-05-15T20:38:11Z</dcterms:modified>
</cp:coreProperties>
</file>